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9"/>
  </p:notesMasterIdLst>
  <p:sldIdLst>
    <p:sldId id="311" r:id="rId2"/>
    <p:sldId id="295" r:id="rId3"/>
    <p:sldId id="300" r:id="rId4"/>
    <p:sldId id="301" r:id="rId5"/>
    <p:sldId id="302" r:id="rId6"/>
    <p:sldId id="307" r:id="rId7"/>
    <p:sldId id="312" r:id="rId8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4" pos="3334" userDrawn="1">
          <p15:clr>
            <a:srgbClr val="A4A3A4"/>
          </p15:clr>
        </p15:guide>
        <p15:guide id="5" pos="1156" userDrawn="1">
          <p15:clr>
            <a:srgbClr val="A4A3A4"/>
          </p15:clr>
        </p15:guide>
        <p15:guide id="6" orient="horz" pos="1344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homas Eschenhagen" initials="TE" lastIdx="11" clrIdx="0">
    <p:extLst>
      <p:ext uri="{19B8F6BF-5375-455C-9EA6-DF929625EA0E}">
        <p15:presenceInfo xmlns:p15="http://schemas.microsoft.com/office/powerpoint/2012/main" userId="Thomas Eschenhagen" providerId="None"/>
      </p:ext>
    </p:extLst>
  </p:cmAuthor>
  <p:cmAuthor id="2" name="Microsoft-Konto" initials="M" lastIdx="1" clrIdx="1">
    <p:extLst>
      <p:ext uri="{19B8F6BF-5375-455C-9EA6-DF929625EA0E}">
        <p15:presenceInfo xmlns:p15="http://schemas.microsoft.com/office/powerpoint/2012/main" userId="bbebdfcae4d7f382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0CECE"/>
    <a:srgbClr val="5B9BD5"/>
    <a:srgbClr val="000000"/>
    <a:srgbClr val="FF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24FC5D4-A4EE-450D-B5DB-3960251F4C69}" v="12" dt="2023-09-20T16:44:51.400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Helle Formatvorlag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073A0DAA-6AF3-43AB-8588-CEC1D06C72B9}" styleName="Mittlere Formatvorlag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675" autoAdjust="0"/>
    <p:restoredTop sz="96362" autoAdjust="0"/>
  </p:normalViewPr>
  <p:slideViewPr>
    <p:cSldViewPr>
      <p:cViewPr varScale="1">
        <p:scale>
          <a:sx n="110" d="100"/>
          <a:sy n="110" d="100"/>
        </p:scale>
        <p:origin x="132" y="78"/>
      </p:cViewPr>
      <p:guideLst>
        <p:guide pos="3334"/>
        <p:guide pos="1156"/>
        <p:guide orient="horz" pos="1344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microsoft.com/office/2016/11/relationships/changesInfo" Target="changesInfos/changesInfo1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Relationship Id="rId22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ussi Koivumäki (TAU)" userId="bdb62f9b-1336-4c27-925f-5d710c4bab40" providerId="ADAL" clId="{E24FC5D4-A4EE-450D-B5DB-3960251F4C69}"/>
    <pc:docChg chg="custSel addSld modSld sldOrd">
      <pc:chgData name="Jussi Koivumäki (TAU)" userId="bdb62f9b-1336-4c27-925f-5d710c4bab40" providerId="ADAL" clId="{E24FC5D4-A4EE-450D-B5DB-3960251F4C69}" dt="2023-09-20T16:45:02.317" v="55" actId="1076"/>
      <pc:docMkLst>
        <pc:docMk/>
      </pc:docMkLst>
      <pc:sldChg chg="modSp mod">
        <pc:chgData name="Jussi Koivumäki (TAU)" userId="bdb62f9b-1336-4c27-925f-5d710c4bab40" providerId="ADAL" clId="{E24FC5D4-A4EE-450D-B5DB-3960251F4C69}" dt="2023-09-20T16:25:53.761" v="16" actId="20577"/>
        <pc:sldMkLst>
          <pc:docMk/>
          <pc:sldMk cId="2131831402" sldId="260"/>
        </pc:sldMkLst>
        <pc:spChg chg="mod">
          <ac:chgData name="Jussi Koivumäki (TAU)" userId="bdb62f9b-1336-4c27-925f-5d710c4bab40" providerId="ADAL" clId="{E24FC5D4-A4EE-450D-B5DB-3960251F4C69}" dt="2023-09-20T16:25:53.761" v="16" actId="20577"/>
          <ac:spMkLst>
            <pc:docMk/>
            <pc:sldMk cId="2131831402" sldId="260"/>
            <ac:spMk id="4" creationId="{00000000-0000-0000-0000-000000000000}"/>
          </ac:spMkLst>
        </pc:spChg>
      </pc:sldChg>
      <pc:sldChg chg="modSp mod">
        <pc:chgData name="Jussi Koivumäki (TAU)" userId="bdb62f9b-1336-4c27-925f-5d710c4bab40" providerId="ADAL" clId="{E24FC5D4-A4EE-450D-B5DB-3960251F4C69}" dt="2023-09-20T16:25:59.309" v="18" actId="20577"/>
        <pc:sldMkLst>
          <pc:docMk/>
          <pc:sldMk cId="918899140" sldId="261"/>
        </pc:sldMkLst>
        <pc:spChg chg="mod">
          <ac:chgData name="Jussi Koivumäki (TAU)" userId="bdb62f9b-1336-4c27-925f-5d710c4bab40" providerId="ADAL" clId="{E24FC5D4-A4EE-450D-B5DB-3960251F4C69}" dt="2023-09-20T16:25:59.309" v="18" actId="20577"/>
          <ac:spMkLst>
            <pc:docMk/>
            <pc:sldMk cId="918899140" sldId="261"/>
            <ac:spMk id="4" creationId="{00000000-0000-0000-0000-000000000000}"/>
          </ac:spMkLst>
        </pc:spChg>
      </pc:sldChg>
      <pc:sldChg chg="modSp mod">
        <pc:chgData name="Jussi Koivumäki (TAU)" userId="bdb62f9b-1336-4c27-925f-5d710c4bab40" providerId="ADAL" clId="{E24FC5D4-A4EE-450D-B5DB-3960251F4C69}" dt="2023-09-20T16:25:41.813" v="11" actId="20577"/>
        <pc:sldMkLst>
          <pc:docMk/>
          <pc:sldMk cId="3004366358" sldId="268"/>
        </pc:sldMkLst>
        <pc:spChg chg="mod">
          <ac:chgData name="Jussi Koivumäki (TAU)" userId="bdb62f9b-1336-4c27-925f-5d710c4bab40" providerId="ADAL" clId="{E24FC5D4-A4EE-450D-B5DB-3960251F4C69}" dt="2023-09-20T16:25:41.813" v="11" actId="20577"/>
          <ac:spMkLst>
            <pc:docMk/>
            <pc:sldMk cId="3004366358" sldId="268"/>
            <ac:spMk id="4" creationId="{00000000-0000-0000-0000-000000000000}"/>
          </ac:spMkLst>
        </pc:spChg>
      </pc:sldChg>
      <pc:sldChg chg="modSp mod">
        <pc:chgData name="Jussi Koivumäki (TAU)" userId="bdb62f9b-1336-4c27-925f-5d710c4bab40" providerId="ADAL" clId="{E24FC5D4-A4EE-450D-B5DB-3960251F4C69}" dt="2023-09-20T16:25:37.122" v="10" actId="20577"/>
        <pc:sldMkLst>
          <pc:docMk/>
          <pc:sldMk cId="1026354360" sldId="283"/>
        </pc:sldMkLst>
        <pc:spChg chg="mod ord">
          <ac:chgData name="Jussi Koivumäki (TAU)" userId="bdb62f9b-1336-4c27-925f-5d710c4bab40" providerId="ADAL" clId="{E24FC5D4-A4EE-450D-B5DB-3960251F4C69}" dt="2023-09-20T16:25:37.122" v="10" actId="20577"/>
          <ac:spMkLst>
            <pc:docMk/>
            <pc:sldMk cId="1026354360" sldId="283"/>
            <ac:spMk id="4" creationId="{00000000-0000-0000-0000-000000000000}"/>
          </ac:spMkLst>
        </pc:spChg>
      </pc:sldChg>
      <pc:sldChg chg="modSp mod ord">
        <pc:chgData name="Jussi Koivumäki (TAU)" userId="bdb62f9b-1336-4c27-925f-5d710c4bab40" providerId="ADAL" clId="{E24FC5D4-A4EE-450D-B5DB-3960251F4C69}" dt="2023-09-20T16:37:15.191" v="22" actId="20577"/>
        <pc:sldMkLst>
          <pc:docMk/>
          <pc:sldMk cId="2101465694" sldId="286"/>
        </pc:sldMkLst>
        <pc:spChg chg="mod">
          <ac:chgData name="Jussi Koivumäki (TAU)" userId="bdb62f9b-1336-4c27-925f-5d710c4bab40" providerId="ADAL" clId="{E24FC5D4-A4EE-450D-B5DB-3960251F4C69}" dt="2023-09-20T16:37:15.191" v="22" actId="20577"/>
          <ac:spMkLst>
            <pc:docMk/>
            <pc:sldMk cId="2101465694" sldId="286"/>
            <ac:spMk id="32" creationId="{00000000-0000-0000-0000-000000000000}"/>
          </ac:spMkLst>
        </pc:spChg>
      </pc:sldChg>
      <pc:sldChg chg="modSp mod ord">
        <pc:chgData name="Jussi Koivumäki (TAU)" userId="bdb62f9b-1336-4c27-925f-5d710c4bab40" providerId="ADAL" clId="{E24FC5D4-A4EE-450D-B5DB-3960251F4C69}" dt="2023-09-20T16:37:55.345" v="29" actId="20577"/>
        <pc:sldMkLst>
          <pc:docMk/>
          <pc:sldMk cId="102453597" sldId="287"/>
        </pc:sldMkLst>
        <pc:spChg chg="mod">
          <ac:chgData name="Jussi Koivumäki (TAU)" userId="bdb62f9b-1336-4c27-925f-5d710c4bab40" providerId="ADAL" clId="{E24FC5D4-A4EE-450D-B5DB-3960251F4C69}" dt="2023-09-20T16:37:55.345" v="29" actId="20577"/>
          <ac:spMkLst>
            <pc:docMk/>
            <pc:sldMk cId="102453597" sldId="287"/>
            <ac:spMk id="22" creationId="{00000000-0000-0000-0000-000000000000}"/>
          </ac:spMkLst>
        </pc:spChg>
      </pc:sldChg>
      <pc:sldChg chg="addSp delSp modSp mod modClrScheme chgLayout">
        <pc:chgData name="Jussi Koivumäki (TAU)" userId="bdb62f9b-1336-4c27-925f-5d710c4bab40" providerId="ADAL" clId="{E24FC5D4-A4EE-450D-B5DB-3960251F4C69}" dt="2023-09-20T16:43:46.997" v="46" actId="1076"/>
        <pc:sldMkLst>
          <pc:docMk/>
          <pc:sldMk cId="2638457304" sldId="295"/>
        </pc:sldMkLst>
        <pc:spChg chg="del mod ord">
          <ac:chgData name="Jussi Koivumäki (TAU)" userId="bdb62f9b-1336-4c27-925f-5d710c4bab40" providerId="ADAL" clId="{E24FC5D4-A4EE-450D-B5DB-3960251F4C69}" dt="2023-09-20T16:42:35.959" v="33" actId="478"/>
          <ac:spMkLst>
            <pc:docMk/>
            <pc:sldMk cId="2638457304" sldId="295"/>
            <ac:spMk id="2" creationId="{00000000-0000-0000-0000-000000000000}"/>
          </ac:spMkLst>
        </pc:spChg>
        <pc:spChg chg="del">
          <ac:chgData name="Jussi Koivumäki (TAU)" userId="bdb62f9b-1336-4c27-925f-5d710c4bab40" providerId="ADAL" clId="{E24FC5D4-A4EE-450D-B5DB-3960251F4C69}" dt="2023-09-20T16:42:32.996" v="32" actId="700"/>
          <ac:spMkLst>
            <pc:docMk/>
            <pc:sldMk cId="2638457304" sldId="295"/>
            <ac:spMk id="3" creationId="{00000000-0000-0000-0000-000000000000}"/>
          </ac:spMkLst>
        </pc:spChg>
        <pc:spChg chg="add mod">
          <ac:chgData name="Jussi Koivumäki (TAU)" userId="bdb62f9b-1336-4c27-925f-5d710c4bab40" providerId="ADAL" clId="{E24FC5D4-A4EE-450D-B5DB-3960251F4C69}" dt="2023-09-20T16:42:54.063" v="37" actId="1076"/>
          <ac:spMkLst>
            <pc:docMk/>
            <pc:sldMk cId="2638457304" sldId="295"/>
            <ac:spMk id="4" creationId="{CCC5AD3A-B1BA-4D53-892A-A7582666E887}"/>
          </ac:spMkLst>
        </pc:spChg>
        <pc:picChg chg="add mod">
          <ac:chgData name="Jussi Koivumäki (TAU)" userId="bdb62f9b-1336-4c27-925f-5d710c4bab40" providerId="ADAL" clId="{E24FC5D4-A4EE-450D-B5DB-3960251F4C69}" dt="2023-09-20T16:43:46.997" v="46" actId="1076"/>
          <ac:picMkLst>
            <pc:docMk/>
            <pc:sldMk cId="2638457304" sldId="295"/>
            <ac:picMk id="6" creationId="{34117C6E-9EE5-F42A-5F1D-94037C7245B0}"/>
          </ac:picMkLst>
        </pc:picChg>
      </pc:sldChg>
      <pc:sldChg chg="modSp mod ord">
        <pc:chgData name="Jussi Koivumäki (TAU)" userId="bdb62f9b-1336-4c27-925f-5d710c4bab40" providerId="ADAL" clId="{E24FC5D4-A4EE-450D-B5DB-3960251F4C69}" dt="2023-09-20T16:25:47.686" v="14" actId="6549"/>
        <pc:sldMkLst>
          <pc:docMk/>
          <pc:sldMk cId="3633085802" sldId="296"/>
        </pc:sldMkLst>
        <pc:spChg chg="mod">
          <ac:chgData name="Jussi Koivumäki (TAU)" userId="bdb62f9b-1336-4c27-925f-5d710c4bab40" providerId="ADAL" clId="{E24FC5D4-A4EE-450D-B5DB-3960251F4C69}" dt="2023-09-20T16:25:47.686" v="14" actId="6549"/>
          <ac:spMkLst>
            <pc:docMk/>
            <pc:sldMk cId="3633085802" sldId="296"/>
            <ac:spMk id="4" creationId="{00000000-0000-0000-0000-000000000000}"/>
          </ac:spMkLst>
        </pc:spChg>
      </pc:sldChg>
      <pc:sldChg chg="addSp delSp modSp new mod modClrScheme chgLayout">
        <pc:chgData name="Jussi Koivumäki (TAU)" userId="bdb62f9b-1336-4c27-925f-5d710c4bab40" providerId="ADAL" clId="{E24FC5D4-A4EE-450D-B5DB-3960251F4C69}" dt="2023-09-20T16:26:04.318" v="19" actId="20577"/>
        <pc:sldMkLst>
          <pc:docMk/>
          <pc:sldMk cId="2278529562" sldId="297"/>
        </pc:sldMkLst>
        <pc:spChg chg="del">
          <ac:chgData name="Jussi Koivumäki (TAU)" userId="bdb62f9b-1336-4c27-925f-5d710c4bab40" providerId="ADAL" clId="{E24FC5D4-A4EE-450D-B5DB-3960251F4C69}" dt="2023-09-20T16:18:52.522" v="1" actId="700"/>
          <ac:spMkLst>
            <pc:docMk/>
            <pc:sldMk cId="2278529562" sldId="297"/>
            <ac:spMk id="2" creationId="{9B679F37-1146-06F9-35DC-7E5C659905ED}"/>
          </ac:spMkLst>
        </pc:spChg>
        <pc:spChg chg="del">
          <ac:chgData name="Jussi Koivumäki (TAU)" userId="bdb62f9b-1336-4c27-925f-5d710c4bab40" providerId="ADAL" clId="{E24FC5D4-A4EE-450D-B5DB-3960251F4C69}" dt="2023-09-20T16:18:52.522" v="1" actId="700"/>
          <ac:spMkLst>
            <pc:docMk/>
            <pc:sldMk cId="2278529562" sldId="297"/>
            <ac:spMk id="3" creationId="{69448CC5-41CB-1F98-CCBD-F318CF58724A}"/>
          </ac:spMkLst>
        </pc:spChg>
        <pc:spChg chg="add mod">
          <ac:chgData name="Jussi Koivumäki (TAU)" userId="bdb62f9b-1336-4c27-925f-5d710c4bab40" providerId="ADAL" clId="{E24FC5D4-A4EE-450D-B5DB-3960251F4C69}" dt="2023-09-20T16:26:04.318" v="19" actId="20577"/>
          <ac:spMkLst>
            <pc:docMk/>
            <pc:sldMk cId="2278529562" sldId="297"/>
            <ac:spMk id="6" creationId="{D3B9CAF7-16BA-7E37-D6F9-21EF1CD04EBF}"/>
          </ac:spMkLst>
        </pc:spChg>
        <pc:picChg chg="add mod">
          <ac:chgData name="Jussi Koivumäki (TAU)" userId="bdb62f9b-1336-4c27-925f-5d710c4bab40" providerId="ADAL" clId="{E24FC5D4-A4EE-450D-B5DB-3960251F4C69}" dt="2023-09-20T16:19:42.134" v="3" actId="931"/>
          <ac:picMkLst>
            <pc:docMk/>
            <pc:sldMk cId="2278529562" sldId="297"/>
            <ac:picMk id="5" creationId="{55659645-3C74-4EE1-9A57-C015B94CC339}"/>
          </ac:picMkLst>
        </pc:picChg>
      </pc:sldChg>
      <pc:sldChg chg="addSp modSp add mod">
        <pc:chgData name="Jussi Koivumäki (TAU)" userId="bdb62f9b-1336-4c27-925f-5d710c4bab40" providerId="ADAL" clId="{E24FC5D4-A4EE-450D-B5DB-3960251F4C69}" dt="2023-09-20T16:37:44.095" v="28" actId="931"/>
        <pc:sldMkLst>
          <pc:docMk/>
          <pc:sldMk cId="395424857" sldId="298"/>
        </pc:sldMkLst>
        <pc:spChg chg="add mod">
          <ac:chgData name="Jussi Koivumäki (TAU)" userId="bdb62f9b-1336-4c27-925f-5d710c4bab40" providerId="ADAL" clId="{E24FC5D4-A4EE-450D-B5DB-3960251F4C69}" dt="2023-09-20T16:37:35.819" v="27" actId="20577"/>
          <ac:spMkLst>
            <pc:docMk/>
            <pc:sldMk cId="395424857" sldId="298"/>
            <ac:spMk id="2" creationId="{B1C284EE-A916-2106-6174-77A656128B42}"/>
          </ac:spMkLst>
        </pc:spChg>
        <pc:picChg chg="add mod">
          <ac:chgData name="Jussi Koivumäki (TAU)" userId="bdb62f9b-1336-4c27-925f-5d710c4bab40" providerId="ADAL" clId="{E24FC5D4-A4EE-450D-B5DB-3960251F4C69}" dt="2023-09-20T16:37:44.095" v="28" actId="931"/>
          <ac:picMkLst>
            <pc:docMk/>
            <pc:sldMk cId="395424857" sldId="298"/>
            <ac:picMk id="4" creationId="{662F400A-E761-0BE8-5D8C-CB7B6DAAB9BB}"/>
          </ac:picMkLst>
        </pc:picChg>
      </pc:sldChg>
      <pc:sldChg chg="addSp modSp add">
        <pc:chgData name="Jussi Koivumäki (TAU)" userId="bdb62f9b-1336-4c27-925f-5d710c4bab40" providerId="ADAL" clId="{E24FC5D4-A4EE-450D-B5DB-3960251F4C69}" dt="2023-09-20T16:38:05.265" v="31" actId="931"/>
        <pc:sldMkLst>
          <pc:docMk/>
          <pc:sldMk cId="49608427" sldId="299"/>
        </pc:sldMkLst>
        <pc:spChg chg="add mod">
          <ac:chgData name="Jussi Koivumäki (TAU)" userId="bdb62f9b-1336-4c27-925f-5d710c4bab40" providerId="ADAL" clId="{E24FC5D4-A4EE-450D-B5DB-3960251F4C69}" dt="2023-09-20T16:37:57.228" v="30"/>
          <ac:spMkLst>
            <pc:docMk/>
            <pc:sldMk cId="49608427" sldId="299"/>
            <ac:spMk id="2" creationId="{CF8D4C68-3DFF-4C95-8C05-79A3C37C467F}"/>
          </ac:spMkLst>
        </pc:spChg>
        <pc:picChg chg="add mod">
          <ac:chgData name="Jussi Koivumäki (TAU)" userId="bdb62f9b-1336-4c27-925f-5d710c4bab40" providerId="ADAL" clId="{E24FC5D4-A4EE-450D-B5DB-3960251F4C69}" dt="2023-09-20T16:38:05.265" v="31" actId="931"/>
          <ac:picMkLst>
            <pc:docMk/>
            <pc:sldMk cId="49608427" sldId="299"/>
            <ac:picMk id="4" creationId="{BF8B832C-A8AF-9130-D37D-B4533581048F}"/>
          </ac:picMkLst>
        </pc:picChg>
      </pc:sldChg>
      <pc:sldChg chg="addSp modSp add mod">
        <pc:chgData name="Jussi Koivumäki (TAU)" userId="bdb62f9b-1336-4c27-925f-5d710c4bab40" providerId="ADAL" clId="{E24FC5D4-A4EE-450D-B5DB-3960251F4C69}" dt="2023-09-20T16:44:11.934" v="49" actId="1076"/>
        <pc:sldMkLst>
          <pc:docMk/>
          <pc:sldMk cId="986050496" sldId="300"/>
        </pc:sldMkLst>
        <pc:spChg chg="mod">
          <ac:chgData name="Jussi Koivumäki (TAU)" userId="bdb62f9b-1336-4c27-925f-5d710c4bab40" providerId="ADAL" clId="{E24FC5D4-A4EE-450D-B5DB-3960251F4C69}" dt="2023-09-20T16:43:15.773" v="43" actId="20577"/>
          <ac:spMkLst>
            <pc:docMk/>
            <pc:sldMk cId="986050496" sldId="300"/>
            <ac:spMk id="4" creationId="{CCC5AD3A-B1BA-4D53-892A-A7582666E887}"/>
          </ac:spMkLst>
        </pc:spChg>
        <pc:picChg chg="add mod">
          <ac:chgData name="Jussi Koivumäki (TAU)" userId="bdb62f9b-1336-4c27-925f-5d710c4bab40" providerId="ADAL" clId="{E24FC5D4-A4EE-450D-B5DB-3960251F4C69}" dt="2023-09-20T16:44:11.934" v="49" actId="1076"/>
          <ac:picMkLst>
            <pc:docMk/>
            <pc:sldMk cId="986050496" sldId="300"/>
            <ac:picMk id="3" creationId="{B1399C94-B1BB-5ACE-9219-52CB8299DCEC}"/>
          </ac:picMkLst>
        </pc:picChg>
      </pc:sldChg>
      <pc:sldChg chg="addSp modSp add mod">
        <pc:chgData name="Jussi Koivumäki (TAU)" userId="bdb62f9b-1336-4c27-925f-5d710c4bab40" providerId="ADAL" clId="{E24FC5D4-A4EE-450D-B5DB-3960251F4C69}" dt="2023-09-20T16:44:44.677" v="52" actId="1076"/>
        <pc:sldMkLst>
          <pc:docMk/>
          <pc:sldMk cId="3126783232" sldId="301"/>
        </pc:sldMkLst>
        <pc:spChg chg="mod">
          <ac:chgData name="Jussi Koivumäki (TAU)" userId="bdb62f9b-1336-4c27-925f-5d710c4bab40" providerId="ADAL" clId="{E24FC5D4-A4EE-450D-B5DB-3960251F4C69}" dt="2023-09-20T16:43:11.229" v="42" actId="20577"/>
          <ac:spMkLst>
            <pc:docMk/>
            <pc:sldMk cId="3126783232" sldId="301"/>
            <ac:spMk id="4" creationId="{CCC5AD3A-B1BA-4D53-892A-A7582666E887}"/>
          </ac:spMkLst>
        </pc:spChg>
        <pc:picChg chg="add mod">
          <ac:chgData name="Jussi Koivumäki (TAU)" userId="bdb62f9b-1336-4c27-925f-5d710c4bab40" providerId="ADAL" clId="{E24FC5D4-A4EE-450D-B5DB-3960251F4C69}" dt="2023-09-20T16:44:44.677" v="52" actId="1076"/>
          <ac:picMkLst>
            <pc:docMk/>
            <pc:sldMk cId="3126783232" sldId="301"/>
            <ac:picMk id="3" creationId="{48133CC2-9320-D14A-2760-E8553E0971E6}"/>
          </ac:picMkLst>
        </pc:picChg>
      </pc:sldChg>
      <pc:sldChg chg="addSp modSp add mod">
        <pc:chgData name="Jussi Koivumäki (TAU)" userId="bdb62f9b-1336-4c27-925f-5d710c4bab40" providerId="ADAL" clId="{E24FC5D4-A4EE-450D-B5DB-3960251F4C69}" dt="2023-09-20T16:45:02.317" v="55" actId="1076"/>
        <pc:sldMkLst>
          <pc:docMk/>
          <pc:sldMk cId="1470956989" sldId="302"/>
        </pc:sldMkLst>
        <pc:spChg chg="mod">
          <ac:chgData name="Jussi Koivumäki (TAU)" userId="bdb62f9b-1336-4c27-925f-5d710c4bab40" providerId="ADAL" clId="{E24FC5D4-A4EE-450D-B5DB-3960251F4C69}" dt="2023-09-20T16:43:06.549" v="41" actId="20577"/>
          <ac:spMkLst>
            <pc:docMk/>
            <pc:sldMk cId="1470956989" sldId="302"/>
            <ac:spMk id="4" creationId="{CCC5AD3A-B1BA-4D53-892A-A7582666E887}"/>
          </ac:spMkLst>
        </pc:spChg>
        <pc:picChg chg="add mod">
          <ac:chgData name="Jussi Koivumäki (TAU)" userId="bdb62f9b-1336-4c27-925f-5d710c4bab40" providerId="ADAL" clId="{E24FC5D4-A4EE-450D-B5DB-3960251F4C69}" dt="2023-09-20T16:45:02.317" v="55" actId="1076"/>
          <ac:picMkLst>
            <pc:docMk/>
            <pc:sldMk cId="1470956989" sldId="302"/>
            <ac:picMk id="3" creationId="{B1EA717E-1FA5-9598-B572-AE8B3A3DB611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CED6430-3916-4C7F-B4DD-08C0C28B419C}" type="datetimeFigureOut">
              <a:rPr lang="en-US" smtClean="0"/>
              <a:t>3/5/2024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33BE65F-0DF2-4046-A4C4-B9ED99D7D31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59667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4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89" indent="0" algn="ctr">
              <a:buNone/>
              <a:defRPr sz="2000"/>
            </a:lvl2pPr>
            <a:lvl3pPr marL="914378" indent="0" algn="ctr">
              <a:buNone/>
              <a:defRPr sz="1800"/>
            </a:lvl3pPr>
            <a:lvl4pPr marL="1371566" indent="0" algn="ctr">
              <a:buNone/>
              <a:defRPr sz="1600"/>
            </a:lvl4pPr>
            <a:lvl5pPr marL="1828754" indent="0" algn="ctr">
              <a:buNone/>
              <a:defRPr sz="1600"/>
            </a:lvl5pPr>
            <a:lvl6pPr marL="2285943" indent="0" algn="ctr">
              <a:buNone/>
              <a:defRPr sz="1600"/>
            </a:lvl6pPr>
            <a:lvl7pPr marL="2743132" indent="0" algn="ctr">
              <a:buNone/>
              <a:defRPr sz="1600"/>
            </a:lvl7pPr>
            <a:lvl8pPr marL="3200320" indent="0" algn="ctr">
              <a:buNone/>
              <a:defRPr sz="1600"/>
            </a:lvl8pPr>
            <a:lvl9pPr marL="3657509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A7EA5-F075-4E09-B93F-57FF4B5CF719}" type="datetimeFigureOut">
              <a:rPr lang="en-US" smtClean="0"/>
              <a:t>3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2CD9A-FFFF-415B-ADCC-53461376544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57593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A7EA5-F075-4E09-B93F-57FF4B5CF719}" type="datetimeFigureOut">
              <a:rPr lang="en-US" smtClean="0"/>
              <a:t>3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2CD9A-FFFF-415B-ADCC-53461376544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99255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6"/>
            <a:ext cx="1971675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365126"/>
            <a:ext cx="5800725" cy="5811838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A7EA5-F075-4E09-B93F-57FF4B5CF719}" type="datetimeFigureOut">
              <a:rPr lang="en-US" smtClean="0"/>
              <a:t>3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2CD9A-FFFF-415B-ADCC-53461376544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73687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A7EA5-F075-4E09-B93F-57FF4B5CF719}" type="datetimeFigureOut">
              <a:rPr lang="en-US" smtClean="0"/>
              <a:t>3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2CD9A-FFFF-415B-ADCC-53461376544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36366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9" y="1709740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9" y="4589465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189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78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13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A7EA5-F075-4E09-B93F-57FF4B5CF719}" type="datetimeFigureOut">
              <a:rPr lang="en-US" smtClean="0"/>
              <a:t>3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2CD9A-FFFF-415B-ADCC-53461376544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728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1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1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A7EA5-F075-4E09-B93F-57FF4B5CF719}" type="datetimeFigureOut">
              <a:rPr lang="en-US" smtClean="0"/>
              <a:t>3/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2CD9A-FFFF-415B-ADCC-53461376544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74634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2" y="365127"/>
            <a:ext cx="78867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4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8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2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1681164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8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2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2505075"/>
            <a:ext cx="3887391" cy="368458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A7EA5-F075-4E09-B93F-57FF4B5CF719}" type="datetimeFigureOut">
              <a:rPr lang="en-US" smtClean="0"/>
              <a:t>3/5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2CD9A-FFFF-415B-ADCC-53461376544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44541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A7EA5-F075-4E09-B93F-57FF4B5CF719}" type="datetimeFigureOut">
              <a:rPr lang="en-US" smtClean="0"/>
              <a:t>3/5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2CD9A-FFFF-415B-ADCC-53461376544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25413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A7EA5-F075-4E09-B93F-57FF4B5CF719}" type="datetimeFigureOut">
              <a:rPr lang="en-US" smtClean="0"/>
              <a:t>3/5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2CD9A-FFFF-415B-ADCC-53461376544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18985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7"/>
            <a:ext cx="462915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8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2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A7EA5-F075-4E09-B93F-57FF4B5CF719}" type="datetimeFigureOut">
              <a:rPr lang="en-US" smtClean="0"/>
              <a:t>3/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2CD9A-FFFF-415B-ADCC-53461376544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13191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7"/>
            <a:ext cx="4629151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8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2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8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2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A7EA5-F075-4E09-B93F-57FF4B5CF719}" type="datetimeFigureOut">
              <a:rPr lang="en-US" smtClean="0"/>
              <a:t>3/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2CD9A-FFFF-415B-ADCC-53461376544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66062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1" y="365127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1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8A7EA5-F075-4E09-B93F-57FF4B5CF719}" type="datetimeFigureOut">
              <a:rPr lang="en-US" smtClean="0"/>
              <a:t>3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1" y="6356352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02CD9A-FFFF-415B-ADCC-53461376544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38041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378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4" indent="-228594" algn="l" defTabSz="914378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83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2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8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5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8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2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8098971" y="6415315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Figure S1</a:t>
            </a:r>
            <a:endParaRPr lang="en-US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7544" y="3011546"/>
            <a:ext cx="8159850" cy="3846454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23728" y="0"/>
            <a:ext cx="5125170" cy="31293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446259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21">
            <a:extLst>
              <a:ext uri="{FF2B5EF4-FFF2-40B4-BE49-F238E27FC236}">
                <a16:creationId xmlns="" xmlns:a16="http://schemas.microsoft.com/office/drawing/2014/main" id="{CCC5AD3A-B1BA-4D53-892A-A7582666E887}"/>
              </a:ext>
            </a:extLst>
          </p:cNvPr>
          <p:cNvSpPr txBox="1"/>
          <p:nvPr/>
        </p:nvSpPr>
        <p:spPr>
          <a:xfrm>
            <a:off x="8101535" y="6488668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Figure </a:t>
            </a:r>
            <a:r>
              <a:rPr lang="de-DE" dirty="0" smtClean="0"/>
              <a:t>S2</a:t>
            </a:r>
            <a:endParaRPr lang="en-US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96" y="1161455"/>
            <a:ext cx="9061656" cy="45350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384573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21">
            <a:extLst>
              <a:ext uri="{FF2B5EF4-FFF2-40B4-BE49-F238E27FC236}">
                <a16:creationId xmlns="" xmlns:a16="http://schemas.microsoft.com/office/drawing/2014/main" id="{CCC5AD3A-B1BA-4D53-892A-A7582666E887}"/>
              </a:ext>
            </a:extLst>
          </p:cNvPr>
          <p:cNvSpPr txBox="1"/>
          <p:nvPr/>
        </p:nvSpPr>
        <p:spPr>
          <a:xfrm>
            <a:off x="8101535" y="6488668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Figure </a:t>
            </a:r>
            <a:r>
              <a:rPr lang="de-DE" dirty="0" smtClean="0"/>
              <a:t>S3</a:t>
            </a:r>
            <a:endParaRPr lang="en-US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33251"/>
            <a:ext cx="9144000" cy="59914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860504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21">
            <a:extLst>
              <a:ext uri="{FF2B5EF4-FFF2-40B4-BE49-F238E27FC236}">
                <a16:creationId xmlns="" xmlns:a16="http://schemas.microsoft.com/office/drawing/2014/main" id="{CCC5AD3A-B1BA-4D53-892A-A7582666E887}"/>
              </a:ext>
            </a:extLst>
          </p:cNvPr>
          <p:cNvSpPr txBox="1"/>
          <p:nvPr/>
        </p:nvSpPr>
        <p:spPr>
          <a:xfrm>
            <a:off x="8101535" y="6488668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Figure </a:t>
            </a:r>
            <a:r>
              <a:rPr lang="de-DE" dirty="0" smtClean="0"/>
              <a:t>S4</a:t>
            </a:r>
            <a:endParaRPr lang="en-US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243148"/>
            <a:ext cx="9144000" cy="43717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267832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21">
            <a:extLst>
              <a:ext uri="{FF2B5EF4-FFF2-40B4-BE49-F238E27FC236}">
                <a16:creationId xmlns="" xmlns:a16="http://schemas.microsoft.com/office/drawing/2014/main" id="{CCC5AD3A-B1BA-4D53-892A-A7582666E887}"/>
              </a:ext>
            </a:extLst>
          </p:cNvPr>
          <p:cNvSpPr txBox="1"/>
          <p:nvPr/>
        </p:nvSpPr>
        <p:spPr>
          <a:xfrm>
            <a:off x="8101535" y="6488668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Figure </a:t>
            </a:r>
            <a:r>
              <a:rPr lang="de-DE" dirty="0" smtClean="0"/>
              <a:t>S5</a:t>
            </a:r>
            <a:endParaRPr lang="en-US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528" y="0"/>
            <a:ext cx="8352928" cy="64975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709569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9512" y="19163"/>
            <a:ext cx="8496944" cy="6606514"/>
          </a:xfrm>
          <a:prstGeom prst="rect">
            <a:avLst/>
          </a:prstGeom>
        </p:spPr>
      </p:pic>
      <p:sp>
        <p:nvSpPr>
          <p:cNvPr id="4" name="Textfeld 21">
            <a:extLst>
              <a:ext uri="{FF2B5EF4-FFF2-40B4-BE49-F238E27FC236}">
                <a16:creationId xmlns="" xmlns:a16="http://schemas.microsoft.com/office/drawing/2014/main" id="{CCC5AD3A-B1BA-4D53-892A-A7582666E887}"/>
              </a:ext>
            </a:extLst>
          </p:cNvPr>
          <p:cNvSpPr txBox="1"/>
          <p:nvPr/>
        </p:nvSpPr>
        <p:spPr>
          <a:xfrm>
            <a:off x="8101535" y="6488668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Figure </a:t>
            </a:r>
            <a:r>
              <a:rPr lang="de-DE" dirty="0" smtClean="0"/>
              <a:t>S6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006114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21">
            <a:extLst>
              <a:ext uri="{FF2B5EF4-FFF2-40B4-BE49-F238E27FC236}">
                <a16:creationId xmlns="" xmlns:a16="http://schemas.microsoft.com/office/drawing/2014/main" id="{CCC5AD3A-B1BA-4D53-892A-A7582666E887}"/>
              </a:ext>
            </a:extLst>
          </p:cNvPr>
          <p:cNvSpPr txBox="1"/>
          <p:nvPr/>
        </p:nvSpPr>
        <p:spPr>
          <a:xfrm>
            <a:off x="8101535" y="6488668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Figure </a:t>
            </a:r>
            <a:r>
              <a:rPr lang="de-DE" dirty="0" smtClean="0"/>
              <a:t>S7</a:t>
            </a:r>
            <a:endParaRPr lang="en-US" dirty="0"/>
          </a:p>
        </p:txBody>
      </p:sp>
      <p:pic>
        <p:nvPicPr>
          <p:cNvPr id="6" name="Grafik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71600" y="1052736"/>
            <a:ext cx="7436724" cy="44644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949942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4</Words>
  <Application>Microsoft Office PowerPoint</Application>
  <PresentationFormat>Bildschirmpräsentation (4:3)</PresentationFormat>
  <Paragraphs>7</Paragraphs>
  <Slides>7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icrosoft-Konto</dc:creator>
  <cp:lastModifiedBy>Microsoft-Konto</cp:lastModifiedBy>
  <cp:revision>341</cp:revision>
  <dcterms:created xsi:type="dcterms:W3CDTF">2022-03-29T11:11:21Z</dcterms:created>
  <dcterms:modified xsi:type="dcterms:W3CDTF">2024-03-05T13:26:13Z</dcterms:modified>
</cp:coreProperties>
</file>